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011863" cy="8569325"/>
  <p:notesSz cx="6858000" cy="9144000"/>
  <p:defaultTextStyle>
    <a:defPPr>
      <a:defRPr lang="en-US"/>
    </a:defPPr>
    <a:lvl1pPr marL="0" algn="l" defTabSz="83320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16601" algn="l" defTabSz="83320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33201" algn="l" defTabSz="83320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49802" algn="l" defTabSz="83320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66403" algn="l" defTabSz="83320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83003" algn="l" defTabSz="83320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99604" algn="l" defTabSz="83320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916204" algn="l" defTabSz="83320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332805" algn="l" defTabSz="83320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1662" y="-102"/>
      </p:cViewPr>
      <p:guideLst>
        <p:guide orient="horz" pos="2699"/>
        <p:guide pos="189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0890" y="2662047"/>
            <a:ext cx="5110084" cy="183685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01780" y="4855951"/>
            <a:ext cx="4208304" cy="218993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66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332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498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664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830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996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162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328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1407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3218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58601" y="343172"/>
            <a:ext cx="1352669" cy="731169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0593" y="343172"/>
            <a:ext cx="3957810" cy="731169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541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394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4896" y="5506585"/>
            <a:ext cx="5110084" cy="1701963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4896" y="3632047"/>
            <a:ext cx="5110084" cy="1874539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660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3320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4980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6640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8300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49960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1620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3280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17666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0593" y="1999511"/>
            <a:ext cx="2655239" cy="5655358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56031" y="1999511"/>
            <a:ext cx="2655239" cy="5655358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7193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0593" y="1918180"/>
            <a:ext cx="2656284" cy="799406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6601" indent="0">
              <a:buNone/>
              <a:defRPr sz="1800" b="1"/>
            </a:lvl2pPr>
            <a:lvl3pPr marL="833201" indent="0">
              <a:buNone/>
              <a:defRPr sz="1600" b="1"/>
            </a:lvl3pPr>
            <a:lvl4pPr marL="1249802" indent="0">
              <a:buNone/>
              <a:defRPr sz="1500" b="1"/>
            </a:lvl4pPr>
            <a:lvl5pPr marL="1666403" indent="0">
              <a:buNone/>
              <a:defRPr sz="1500" b="1"/>
            </a:lvl5pPr>
            <a:lvl6pPr marL="2083003" indent="0">
              <a:buNone/>
              <a:defRPr sz="1500" b="1"/>
            </a:lvl6pPr>
            <a:lvl7pPr marL="2499604" indent="0">
              <a:buNone/>
              <a:defRPr sz="1500" b="1"/>
            </a:lvl7pPr>
            <a:lvl8pPr marL="2916204" indent="0">
              <a:buNone/>
              <a:defRPr sz="1500" b="1"/>
            </a:lvl8pPr>
            <a:lvl9pPr marL="3332805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0593" y="2717586"/>
            <a:ext cx="2656284" cy="4937281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53943" y="1918180"/>
            <a:ext cx="2657327" cy="799406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6601" indent="0">
              <a:buNone/>
              <a:defRPr sz="1800" b="1"/>
            </a:lvl2pPr>
            <a:lvl3pPr marL="833201" indent="0">
              <a:buNone/>
              <a:defRPr sz="1600" b="1"/>
            </a:lvl3pPr>
            <a:lvl4pPr marL="1249802" indent="0">
              <a:buNone/>
              <a:defRPr sz="1500" b="1"/>
            </a:lvl4pPr>
            <a:lvl5pPr marL="1666403" indent="0">
              <a:buNone/>
              <a:defRPr sz="1500" b="1"/>
            </a:lvl5pPr>
            <a:lvl6pPr marL="2083003" indent="0">
              <a:buNone/>
              <a:defRPr sz="1500" b="1"/>
            </a:lvl6pPr>
            <a:lvl7pPr marL="2499604" indent="0">
              <a:buNone/>
              <a:defRPr sz="1500" b="1"/>
            </a:lvl7pPr>
            <a:lvl8pPr marL="2916204" indent="0">
              <a:buNone/>
              <a:defRPr sz="1500" b="1"/>
            </a:lvl8pPr>
            <a:lvl9pPr marL="3332805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53943" y="2717586"/>
            <a:ext cx="2657327" cy="4937281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15900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6954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1290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0593" y="341186"/>
            <a:ext cx="1977862" cy="1452025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50471" y="341187"/>
            <a:ext cx="3360799" cy="7313682"/>
          </a:xfrm>
        </p:spPr>
        <p:txBody>
          <a:bodyPr/>
          <a:lstStyle>
            <a:lvl1pPr>
              <a:defRPr sz="29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0593" y="1793212"/>
            <a:ext cx="1977862" cy="5861657"/>
          </a:xfrm>
        </p:spPr>
        <p:txBody>
          <a:bodyPr/>
          <a:lstStyle>
            <a:lvl1pPr marL="0" indent="0">
              <a:buNone/>
              <a:defRPr sz="1300"/>
            </a:lvl1pPr>
            <a:lvl2pPr marL="416601" indent="0">
              <a:buNone/>
              <a:defRPr sz="1100"/>
            </a:lvl2pPr>
            <a:lvl3pPr marL="833201" indent="0">
              <a:buNone/>
              <a:defRPr sz="900"/>
            </a:lvl3pPr>
            <a:lvl4pPr marL="1249802" indent="0">
              <a:buNone/>
              <a:defRPr sz="800"/>
            </a:lvl4pPr>
            <a:lvl5pPr marL="1666403" indent="0">
              <a:buNone/>
              <a:defRPr sz="800"/>
            </a:lvl5pPr>
            <a:lvl6pPr marL="2083003" indent="0">
              <a:buNone/>
              <a:defRPr sz="800"/>
            </a:lvl6pPr>
            <a:lvl7pPr marL="2499604" indent="0">
              <a:buNone/>
              <a:defRPr sz="800"/>
            </a:lvl7pPr>
            <a:lvl8pPr marL="2916204" indent="0">
              <a:buNone/>
              <a:defRPr sz="800"/>
            </a:lvl8pPr>
            <a:lvl9pPr marL="3332805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8333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78367" y="5998528"/>
            <a:ext cx="3607118" cy="7081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78367" y="765685"/>
            <a:ext cx="3607118" cy="5141595"/>
          </a:xfrm>
        </p:spPr>
        <p:txBody>
          <a:bodyPr/>
          <a:lstStyle>
            <a:lvl1pPr marL="0" indent="0">
              <a:buNone/>
              <a:defRPr sz="2900"/>
            </a:lvl1pPr>
            <a:lvl2pPr marL="416601" indent="0">
              <a:buNone/>
              <a:defRPr sz="2600"/>
            </a:lvl2pPr>
            <a:lvl3pPr marL="833201" indent="0">
              <a:buNone/>
              <a:defRPr sz="2200"/>
            </a:lvl3pPr>
            <a:lvl4pPr marL="1249802" indent="0">
              <a:buNone/>
              <a:defRPr sz="1800"/>
            </a:lvl4pPr>
            <a:lvl5pPr marL="1666403" indent="0">
              <a:buNone/>
              <a:defRPr sz="1800"/>
            </a:lvl5pPr>
            <a:lvl6pPr marL="2083003" indent="0">
              <a:buNone/>
              <a:defRPr sz="1800"/>
            </a:lvl6pPr>
            <a:lvl7pPr marL="2499604" indent="0">
              <a:buNone/>
              <a:defRPr sz="1800"/>
            </a:lvl7pPr>
            <a:lvl8pPr marL="2916204" indent="0">
              <a:buNone/>
              <a:defRPr sz="1800"/>
            </a:lvl8pPr>
            <a:lvl9pPr marL="3332805" indent="0">
              <a:buNone/>
              <a:defRPr sz="18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78367" y="6706688"/>
            <a:ext cx="3607118" cy="1005705"/>
          </a:xfrm>
        </p:spPr>
        <p:txBody>
          <a:bodyPr/>
          <a:lstStyle>
            <a:lvl1pPr marL="0" indent="0">
              <a:buNone/>
              <a:defRPr sz="1300"/>
            </a:lvl1pPr>
            <a:lvl2pPr marL="416601" indent="0">
              <a:buNone/>
              <a:defRPr sz="1100"/>
            </a:lvl2pPr>
            <a:lvl3pPr marL="833201" indent="0">
              <a:buNone/>
              <a:defRPr sz="900"/>
            </a:lvl3pPr>
            <a:lvl4pPr marL="1249802" indent="0">
              <a:buNone/>
              <a:defRPr sz="800"/>
            </a:lvl4pPr>
            <a:lvl5pPr marL="1666403" indent="0">
              <a:buNone/>
              <a:defRPr sz="800"/>
            </a:lvl5pPr>
            <a:lvl6pPr marL="2083003" indent="0">
              <a:buNone/>
              <a:defRPr sz="800"/>
            </a:lvl6pPr>
            <a:lvl7pPr marL="2499604" indent="0">
              <a:buNone/>
              <a:defRPr sz="800"/>
            </a:lvl7pPr>
            <a:lvl8pPr marL="2916204" indent="0">
              <a:buNone/>
              <a:defRPr sz="800"/>
            </a:lvl8pPr>
            <a:lvl9pPr marL="3332805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9374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0593" y="343170"/>
            <a:ext cx="5410677" cy="1428221"/>
          </a:xfrm>
          <a:prstGeom prst="rect">
            <a:avLst/>
          </a:prstGeom>
        </p:spPr>
        <p:txBody>
          <a:bodyPr vert="horz" lIns="83320" tIns="41660" rIns="83320" bIns="4166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0593" y="1999511"/>
            <a:ext cx="5410677" cy="5655358"/>
          </a:xfrm>
          <a:prstGeom prst="rect">
            <a:avLst/>
          </a:prstGeom>
        </p:spPr>
        <p:txBody>
          <a:bodyPr vert="horz" lIns="83320" tIns="41660" rIns="83320" bIns="4166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0593" y="7942496"/>
            <a:ext cx="1402768" cy="456237"/>
          </a:xfrm>
          <a:prstGeom prst="rect">
            <a:avLst/>
          </a:prstGeom>
        </p:spPr>
        <p:txBody>
          <a:bodyPr vert="horz" lIns="83320" tIns="41660" rIns="83320" bIns="41660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9C67E-E361-41B0-B428-8C02FB87A0D6}" type="datetimeFigureOut">
              <a:rPr lang="en-GB" smtClean="0"/>
              <a:t>26/11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54053" y="7942496"/>
            <a:ext cx="1903757" cy="456237"/>
          </a:xfrm>
          <a:prstGeom prst="rect">
            <a:avLst/>
          </a:prstGeom>
        </p:spPr>
        <p:txBody>
          <a:bodyPr vert="horz" lIns="83320" tIns="41660" rIns="83320" bIns="41660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08502" y="7942496"/>
            <a:ext cx="1402768" cy="456237"/>
          </a:xfrm>
          <a:prstGeom prst="rect">
            <a:avLst/>
          </a:prstGeom>
        </p:spPr>
        <p:txBody>
          <a:bodyPr vert="horz" lIns="83320" tIns="41660" rIns="83320" bIns="41660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163574-8D99-4D5E-9412-F2368AE8219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060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33201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2450" indent="-312450" algn="l" defTabSz="833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76976" indent="-260375" algn="l" defTabSz="833201" rtl="0" eaLnBrk="1" latinLnBrk="0" hangingPunct="1">
        <a:spcBef>
          <a:spcPct val="20000"/>
        </a:spcBef>
        <a:buFont typeface="Arial" panose="020B0604020202020204" pitchFamily="34" charset="0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41502" indent="-208300" algn="l" defTabSz="833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58102" indent="-208300" algn="l" defTabSz="833201" rtl="0" eaLnBrk="1" latinLnBrk="0" hangingPunct="1">
        <a:spcBef>
          <a:spcPct val="20000"/>
        </a:spcBef>
        <a:buFont typeface="Arial" panose="020B0604020202020204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74703" indent="-208300" algn="l" defTabSz="833201" rtl="0" eaLnBrk="1" latinLnBrk="0" hangingPunct="1">
        <a:spcBef>
          <a:spcPct val="20000"/>
        </a:spcBef>
        <a:buFont typeface="Arial" panose="020B0604020202020204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91304" indent="-208300" algn="l" defTabSz="833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07904" indent="-208300" algn="l" defTabSz="833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24505" indent="-208300" algn="l" defTabSz="833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41105" indent="-208300" algn="l" defTabSz="833201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3320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16601" algn="l" defTabSz="83320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33201" algn="l" defTabSz="83320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49802" algn="l" defTabSz="83320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66403" algn="l" defTabSz="83320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83003" algn="l" defTabSz="83320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99604" algn="l" defTabSz="83320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916204" algn="l" defTabSz="83320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332805" algn="l" defTabSz="83320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074913"/>
              </p:ext>
            </p:extLst>
          </p:nvPr>
        </p:nvGraphicFramePr>
        <p:xfrm>
          <a:off x="2887134" y="1198590"/>
          <a:ext cx="2565927" cy="31197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5" r:id="rId3" imgW="2980800" imgH="3328200" progId="Prism5.Document">
                  <p:embed/>
                </p:oleObj>
              </mc:Choice>
              <mc:Fallback>
                <p:oleObj name="Prism 5" r:id="rId3" imgW="2980800" imgH="33282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87134" y="1198590"/>
                        <a:ext cx="2565927" cy="31197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99230" y="684262"/>
            <a:ext cx="2425295" cy="330355"/>
          </a:xfrm>
          <a:prstGeom prst="rect">
            <a:avLst/>
          </a:prstGeom>
          <a:noFill/>
        </p:spPr>
        <p:txBody>
          <a:bodyPr wrap="none" lIns="83320" tIns="41660" rIns="83320" bIns="41660" rtlCol="0">
            <a:spAutoFit/>
          </a:bodyPr>
          <a:lstStyle/>
          <a:p>
            <a:r>
              <a:rPr lang="en-GB" dirty="0" smtClean="0"/>
              <a:t>SDC, Supplemental </a:t>
            </a:r>
            <a:r>
              <a:rPr lang="en-GB" dirty="0" smtClean="0"/>
              <a:t>figure 1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557659" y="1188318"/>
            <a:ext cx="286890" cy="330355"/>
          </a:xfrm>
          <a:prstGeom prst="rect">
            <a:avLst/>
          </a:prstGeom>
          <a:noFill/>
        </p:spPr>
        <p:txBody>
          <a:bodyPr wrap="none" lIns="83320" tIns="41660" rIns="83320" bIns="41660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0860066"/>
              </p:ext>
            </p:extLst>
          </p:nvPr>
        </p:nvGraphicFramePr>
        <p:xfrm>
          <a:off x="674223" y="1188318"/>
          <a:ext cx="2565927" cy="31108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5" r:id="rId5" imgW="2877120" imgH="3319200" progId="Prism5.Document">
                  <p:embed/>
                </p:oleObj>
              </mc:Choice>
              <mc:Fallback>
                <p:oleObj name="Prism 5" r:id="rId5" imgW="2877120" imgH="33192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4223" y="1188318"/>
                        <a:ext cx="2565927" cy="311084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792206" y="1188318"/>
            <a:ext cx="280478" cy="330355"/>
          </a:xfrm>
          <a:prstGeom prst="rect">
            <a:avLst/>
          </a:prstGeom>
          <a:noFill/>
        </p:spPr>
        <p:txBody>
          <a:bodyPr wrap="none" lIns="83320" tIns="41660" rIns="83320" bIns="41660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sp>
        <p:nvSpPr>
          <p:cNvPr id="9" name="Rectangle 8"/>
          <p:cNvSpPr/>
          <p:nvPr/>
        </p:nvSpPr>
        <p:spPr>
          <a:xfrm>
            <a:off x="772541" y="4356670"/>
            <a:ext cx="4321622" cy="3469676"/>
          </a:xfrm>
          <a:prstGeom prst="rect">
            <a:avLst/>
          </a:prstGeom>
        </p:spPr>
        <p:txBody>
          <a:bodyPr wrap="square" lIns="83320" tIns="41660" rIns="83320" bIns="4166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suppressive capacity of Treg cell populations at 1:8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Treg:PBMC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ratio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200000"/>
              </a:lnSpc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ercentage of suppressive capacity of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int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mTregs (n=6 donors) and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naive Tregs (n=5 donors)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expansion in the presence of DMSO or TAC. Suppressive capacity is represented as percentage of suppression of CD4 effector cell proliferation when 1.25x10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naive Tregs or CD25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int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mTregs were incubated along with 1x10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PMBCs. Each data point represents the average of 3 replicate wells in the suppressive assay of each donor. </a:t>
            </a:r>
          </a:p>
        </p:txBody>
      </p:sp>
    </p:spTree>
    <p:extLst>
      <p:ext uri="{BB962C8B-B14F-4D97-AF65-F5344CB8AC3E}">
        <p14:creationId xmlns:p14="http://schemas.microsoft.com/office/powerpoint/2010/main" val="25322604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05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5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a Arroyo Hornero</dc:creator>
  <cp:lastModifiedBy>Rebeca Arroyo Hornero</cp:lastModifiedBy>
  <cp:revision>3</cp:revision>
  <dcterms:created xsi:type="dcterms:W3CDTF">2015-11-26T20:07:32Z</dcterms:created>
  <dcterms:modified xsi:type="dcterms:W3CDTF">2015-11-26T20:15:33Z</dcterms:modified>
</cp:coreProperties>
</file>